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2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40BBD4-3B6F-4350-9ECF-F4EF7109C2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362B2-2FE2-4AEE-9F49-B3E14F5CBC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4EB27D-89D0-4B96-8E92-16A9570616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FF615-3C59-4D06-974F-E50872FEDA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48A4D-4DC0-4841-9BCF-22FE4C535B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D7F4F-D9D1-4951-BE43-DEC5145820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F1C18-EB03-43F8-9020-C27C2BC6C3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D2F244-2050-49BD-AA66-B305B64EAB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31B42D-2086-499B-8635-A8186BEA3F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D8637-BAC5-41E9-B308-346F23D15B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E4F68-2CE2-4EEC-A1A8-B91E963721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6C5751-4590-4FD4-A914-73E12D33B2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BC85A8C-5467-49A4-9ACE-E24DF1ED41F8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1CA10D1-B620-444F-B995-0A6A2026CDA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image" Target="../media/image20.png"/><Relationship Id="rId8" Type="http://schemas.openxmlformats.org/officeDocument/2006/relationships/image" Target="../media/image21.png"/><Relationship Id="rId9" Type="http://schemas.openxmlformats.org/officeDocument/2006/relationships/image" Target="../media/image22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6"/>
          <p:cNvSpPr/>
          <p:nvPr/>
        </p:nvSpPr>
        <p:spPr>
          <a:xfrm rot="16200000">
            <a:off x="2948400" y="3355200"/>
            <a:ext cx="984240" cy="41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Aft>
                <a:spcPts val="601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ntrol siR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spcAft>
                <a:spcPts val="601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R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siR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8"/>
          <p:cNvSpPr/>
          <p:nvPr/>
        </p:nvSpPr>
        <p:spPr>
          <a:xfrm>
            <a:off x="2262240" y="4071960"/>
            <a:ext cx="1025640" cy="214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80000"/>
              </a:lnSpc>
              <a:spcAft>
                <a:spcPts val="1800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TEN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80000"/>
              </a:lnSpc>
              <a:spcAft>
                <a:spcPts val="1800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kt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80000"/>
              </a:lnSpc>
              <a:spcAft>
                <a:spcPts val="1800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-Akt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80000"/>
              </a:lnSpc>
              <a:spcAft>
                <a:spcPts val="1800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-GSK-3</a:t>
            </a: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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80000"/>
              </a:lnSpc>
              <a:spcAft>
                <a:spcPts val="1800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yclin D1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80000"/>
              </a:lnSpc>
              <a:spcAft>
                <a:spcPts val="1800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Symbol"/>
              </a:rPr>
              <a:t>BRG1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80000"/>
              </a:lnSpc>
              <a:spcAft>
                <a:spcPts val="1800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actin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54" descr=""/>
          <p:cNvPicPr/>
          <p:nvPr/>
        </p:nvPicPr>
        <p:blipFill>
          <a:blip r:embed="rId1"/>
          <a:stretch/>
        </p:blipFill>
        <p:spPr>
          <a:xfrm>
            <a:off x="3195720" y="5999040"/>
            <a:ext cx="503280" cy="2876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6" descr=""/>
          <p:cNvPicPr/>
          <p:nvPr/>
        </p:nvPicPr>
        <p:blipFill>
          <a:blip r:embed="rId2"/>
          <a:stretch/>
        </p:blipFill>
        <p:spPr>
          <a:xfrm>
            <a:off x="3195720" y="5668920"/>
            <a:ext cx="511200" cy="2872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57" descr=""/>
          <p:cNvPicPr/>
          <p:nvPr/>
        </p:nvPicPr>
        <p:blipFill>
          <a:blip r:embed="rId3"/>
          <a:stretch/>
        </p:blipFill>
        <p:spPr>
          <a:xfrm>
            <a:off x="3193920" y="5338800"/>
            <a:ext cx="511200" cy="2872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58" descr=""/>
          <p:cNvPicPr/>
          <p:nvPr/>
        </p:nvPicPr>
        <p:blipFill>
          <a:blip r:embed="rId4"/>
          <a:stretch/>
        </p:blipFill>
        <p:spPr>
          <a:xfrm>
            <a:off x="3195720" y="5011560"/>
            <a:ext cx="511200" cy="28764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59" descr=""/>
          <p:cNvPicPr/>
          <p:nvPr/>
        </p:nvPicPr>
        <p:blipFill>
          <a:blip r:embed="rId5"/>
          <a:stretch/>
        </p:blipFill>
        <p:spPr>
          <a:xfrm>
            <a:off x="3193920" y="4689360"/>
            <a:ext cx="511200" cy="28728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60" descr=""/>
          <p:cNvPicPr/>
          <p:nvPr/>
        </p:nvPicPr>
        <p:blipFill>
          <a:blip r:embed="rId6"/>
          <a:stretch/>
        </p:blipFill>
        <p:spPr>
          <a:xfrm>
            <a:off x="3201840" y="4357800"/>
            <a:ext cx="503280" cy="287280"/>
          </a:xfrm>
          <a:prstGeom prst="rect">
            <a:avLst/>
          </a:prstGeom>
          <a:ln w="0">
            <a:noFill/>
          </a:ln>
        </p:spPr>
      </p:pic>
      <p:sp>
        <p:nvSpPr>
          <p:cNvPr id="49" name="Text Box 61"/>
          <p:cNvSpPr/>
          <p:nvPr/>
        </p:nvSpPr>
        <p:spPr>
          <a:xfrm>
            <a:off x="3156840" y="2955960"/>
            <a:ext cx="557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W4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63" descr=""/>
          <p:cNvPicPr/>
          <p:nvPr/>
        </p:nvPicPr>
        <p:blipFill>
          <a:blip r:embed="rId7"/>
          <a:stretch/>
        </p:blipFill>
        <p:spPr>
          <a:xfrm>
            <a:off x="3195720" y="4019400"/>
            <a:ext cx="511200" cy="287640"/>
          </a:xfrm>
          <a:prstGeom prst="rect">
            <a:avLst/>
          </a:prstGeom>
          <a:ln w="0">
            <a:noFill/>
          </a:ln>
        </p:spPr>
      </p:pic>
      <p:sp>
        <p:nvSpPr>
          <p:cNvPr id="51" name="テキスト ボックス 3"/>
          <p:cNvSpPr/>
          <p:nvPr/>
        </p:nvSpPr>
        <p:spPr>
          <a:xfrm>
            <a:off x="2137680" y="0"/>
            <a:ext cx="255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data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12"/>
          <p:cNvSpPr/>
          <p:nvPr/>
        </p:nvSpPr>
        <p:spPr>
          <a:xfrm>
            <a:off x="363600" y="7348680"/>
            <a:ext cx="61722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data S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s of transduct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G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iRNA into CRC-derived SW480 cells. Knockdown of BRG1 was  confirmed by Western blot. Altered expressions of the PI3K-Akt signaling -related molecules (PTEN, Akt, p-Akt, p-GSK-3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cyclin D1) were investigated.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ctin was used as a loading contro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テキスト ボックス 3"/>
          <p:cNvSpPr/>
          <p:nvPr/>
        </p:nvSpPr>
        <p:spPr>
          <a:xfrm>
            <a:off x="2137680" y="0"/>
            <a:ext cx="255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data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4"/>
          <p:cNvSpPr/>
          <p:nvPr/>
        </p:nvSpPr>
        <p:spPr>
          <a:xfrm>
            <a:off x="2476440" y="9536040"/>
            <a:ext cx="184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Watanabe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oup 88"/>
          <p:cNvGrpSpPr/>
          <p:nvPr/>
        </p:nvGrpSpPr>
        <p:grpSpPr>
          <a:xfrm>
            <a:off x="998640" y="3463920"/>
            <a:ext cx="2352600" cy="1630080"/>
            <a:chOff x="998640" y="3463920"/>
            <a:chExt cx="2352600" cy="1630080"/>
          </a:xfrm>
        </p:grpSpPr>
        <p:pic>
          <p:nvPicPr>
            <p:cNvPr id="56" name="Picture 58" descr=""/>
            <p:cNvPicPr/>
            <p:nvPr/>
          </p:nvPicPr>
          <p:blipFill>
            <a:blip r:embed="rId1"/>
            <a:stretch/>
          </p:blipFill>
          <p:spPr>
            <a:xfrm>
              <a:off x="1235160" y="3603600"/>
              <a:ext cx="2116080" cy="1377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テキスト ボックス 22"/>
            <p:cNvSpPr/>
            <p:nvPr/>
          </p:nvSpPr>
          <p:spPr>
            <a:xfrm rot="16200000">
              <a:off x="352080" y="4110120"/>
              <a:ext cx="1630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K3CB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relative express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/Cyclophilin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テキスト ボックス 23"/>
            <p:cNvSpPr/>
            <p:nvPr/>
          </p:nvSpPr>
          <p:spPr>
            <a:xfrm>
              <a:off x="1482840" y="4862520"/>
              <a:ext cx="90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テキスト ボックス 24"/>
            <p:cNvSpPr/>
            <p:nvPr/>
          </p:nvSpPr>
          <p:spPr>
            <a:xfrm>
              <a:off x="2390760" y="4862520"/>
              <a:ext cx="90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G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Group 89"/>
          <p:cNvGrpSpPr/>
          <p:nvPr/>
        </p:nvGrpSpPr>
        <p:grpSpPr>
          <a:xfrm>
            <a:off x="1000080" y="5111640"/>
            <a:ext cx="2341440" cy="1582560"/>
            <a:chOff x="1000080" y="5111640"/>
            <a:chExt cx="2341440" cy="1582560"/>
          </a:xfrm>
        </p:grpSpPr>
        <p:pic>
          <p:nvPicPr>
            <p:cNvPr id="61" name="Picture 61" descr=""/>
            <p:cNvPicPr/>
            <p:nvPr/>
          </p:nvPicPr>
          <p:blipFill>
            <a:blip r:embed="rId2"/>
            <a:stretch/>
          </p:blipFill>
          <p:spPr>
            <a:xfrm>
              <a:off x="1239840" y="5127480"/>
              <a:ext cx="2101680" cy="1400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テキスト ボックス 26"/>
            <p:cNvSpPr/>
            <p:nvPr/>
          </p:nvSpPr>
          <p:spPr>
            <a:xfrm rot="16200000">
              <a:off x="377280" y="5734080"/>
              <a:ext cx="1582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K3CG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relative express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/Cyclophilin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テキスト ボックス 27"/>
            <p:cNvSpPr/>
            <p:nvPr/>
          </p:nvSpPr>
          <p:spPr>
            <a:xfrm>
              <a:off x="1482840" y="6405480"/>
              <a:ext cx="90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テキスト ボックス 28"/>
            <p:cNvSpPr/>
            <p:nvPr/>
          </p:nvSpPr>
          <p:spPr>
            <a:xfrm>
              <a:off x="2382840" y="6405480"/>
              <a:ext cx="90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G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Group 90"/>
          <p:cNvGrpSpPr/>
          <p:nvPr/>
        </p:nvGrpSpPr>
        <p:grpSpPr>
          <a:xfrm>
            <a:off x="3436920" y="2046240"/>
            <a:ext cx="2344680" cy="1581120"/>
            <a:chOff x="3436920" y="2046240"/>
            <a:chExt cx="2344680" cy="1581120"/>
          </a:xfrm>
        </p:grpSpPr>
        <p:pic>
          <p:nvPicPr>
            <p:cNvPr id="66" name="Picture 54" descr=""/>
            <p:cNvPicPr/>
            <p:nvPr/>
          </p:nvPicPr>
          <p:blipFill>
            <a:blip r:embed="rId3"/>
            <a:stretch/>
          </p:blipFill>
          <p:spPr>
            <a:xfrm>
              <a:off x="3676680" y="2046240"/>
              <a:ext cx="2104920" cy="1419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テキスト ボックス 30"/>
            <p:cNvSpPr/>
            <p:nvPr/>
          </p:nvSpPr>
          <p:spPr>
            <a:xfrm rot="16200000">
              <a:off x="2835360" y="2688480"/>
              <a:ext cx="1540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K3CA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relative express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/Cyclophilin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テキスト ボックス 31"/>
            <p:cNvSpPr/>
            <p:nvPr/>
          </p:nvSpPr>
          <p:spPr>
            <a:xfrm>
              <a:off x="3917880" y="3342960"/>
              <a:ext cx="90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テキスト ボックス 32"/>
            <p:cNvSpPr/>
            <p:nvPr/>
          </p:nvSpPr>
          <p:spPr>
            <a:xfrm>
              <a:off x="4817880" y="3342960"/>
              <a:ext cx="90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G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Group 91"/>
          <p:cNvGrpSpPr/>
          <p:nvPr/>
        </p:nvGrpSpPr>
        <p:grpSpPr>
          <a:xfrm>
            <a:off x="3444840" y="3574800"/>
            <a:ext cx="2333520" cy="1662120"/>
            <a:chOff x="3444840" y="3574800"/>
            <a:chExt cx="2333520" cy="1662120"/>
          </a:xfrm>
        </p:grpSpPr>
        <p:pic>
          <p:nvPicPr>
            <p:cNvPr id="71" name="Picture 55" descr=""/>
            <p:cNvPicPr/>
            <p:nvPr/>
          </p:nvPicPr>
          <p:blipFill>
            <a:blip r:embed="rId4"/>
            <a:stretch/>
          </p:blipFill>
          <p:spPr>
            <a:xfrm>
              <a:off x="3676680" y="3606840"/>
              <a:ext cx="2101680" cy="140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テキスト ボックス 34"/>
            <p:cNvSpPr/>
            <p:nvPr/>
          </p:nvSpPr>
          <p:spPr>
            <a:xfrm rot="16200000">
              <a:off x="2782440" y="4237200"/>
              <a:ext cx="1662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K3CD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relative express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/Cyclophilin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テキスト ボックス 35"/>
            <p:cNvSpPr/>
            <p:nvPr/>
          </p:nvSpPr>
          <p:spPr>
            <a:xfrm>
              <a:off x="3917880" y="4888080"/>
              <a:ext cx="90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テキスト ボックス 36"/>
            <p:cNvSpPr/>
            <p:nvPr/>
          </p:nvSpPr>
          <p:spPr>
            <a:xfrm>
              <a:off x="4817880" y="4888080"/>
              <a:ext cx="90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G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Group 87"/>
          <p:cNvGrpSpPr/>
          <p:nvPr/>
        </p:nvGrpSpPr>
        <p:grpSpPr>
          <a:xfrm>
            <a:off x="981000" y="2063880"/>
            <a:ext cx="2355840" cy="1514520"/>
            <a:chOff x="981000" y="2063880"/>
            <a:chExt cx="2355840" cy="1514520"/>
          </a:xfrm>
        </p:grpSpPr>
        <p:pic>
          <p:nvPicPr>
            <p:cNvPr id="76" name="Picture 63" descr=""/>
            <p:cNvPicPr/>
            <p:nvPr/>
          </p:nvPicPr>
          <p:blipFill>
            <a:blip r:embed="rId5"/>
            <a:stretch/>
          </p:blipFill>
          <p:spPr>
            <a:xfrm>
              <a:off x="1235160" y="2063880"/>
              <a:ext cx="2101680" cy="140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テキスト ボックス 18"/>
            <p:cNvSpPr/>
            <p:nvPr/>
          </p:nvSpPr>
          <p:spPr>
            <a:xfrm rot="16200000">
              <a:off x="428040" y="2688120"/>
              <a:ext cx="1442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DK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relative express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/Cyclophilin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テキスト ボックス 19"/>
            <p:cNvSpPr/>
            <p:nvPr/>
          </p:nvSpPr>
          <p:spPr>
            <a:xfrm>
              <a:off x="1482840" y="3343320"/>
              <a:ext cx="90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テキスト ボックス 20"/>
            <p:cNvSpPr/>
            <p:nvPr/>
          </p:nvSpPr>
          <p:spPr>
            <a:xfrm>
              <a:off x="2382840" y="3343320"/>
              <a:ext cx="90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G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68"/>
            <p:cNvSpPr/>
            <p:nvPr/>
          </p:nvSpPr>
          <p:spPr>
            <a:xfrm>
              <a:off x="2239560" y="210996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Group 92"/>
          <p:cNvGrpSpPr/>
          <p:nvPr/>
        </p:nvGrpSpPr>
        <p:grpSpPr>
          <a:xfrm>
            <a:off x="3435480" y="5124600"/>
            <a:ext cx="2342880" cy="1558440"/>
            <a:chOff x="3435480" y="5124600"/>
            <a:chExt cx="2342880" cy="1558440"/>
          </a:xfrm>
        </p:grpSpPr>
        <p:pic>
          <p:nvPicPr>
            <p:cNvPr id="82" name="Picture 66" descr=""/>
            <p:cNvPicPr/>
            <p:nvPr/>
          </p:nvPicPr>
          <p:blipFill>
            <a:blip r:embed="rId6"/>
            <a:stretch/>
          </p:blipFill>
          <p:spPr>
            <a:xfrm>
              <a:off x="3676680" y="5124600"/>
              <a:ext cx="2101680" cy="140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テキスト ボックス 38"/>
            <p:cNvSpPr/>
            <p:nvPr/>
          </p:nvSpPr>
          <p:spPr>
            <a:xfrm rot="16200000">
              <a:off x="2856600" y="5766840"/>
              <a:ext cx="1495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K3D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relative express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/Cyclophilin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テキスト ボックス 39"/>
            <p:cNvSpPr/>
            <p:nvPr/>
          </p:nvSpPr>
          <p:spPr>
            <a:xfrm>
              <a:off x="3917880" y="6405840"/>
              <a:ext cx="90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テキスト ボックス 40"/>
            <p:cNvSpPr/>
            <p:nvPr/>
          </p:nvSpPr>
          <p:spPr>
            <a:xfrm>
              <a:off x="4817880" y="6405840"/>
              <a:ext cx="90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G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69"/>
            <p:cNvSpPr/>
            <p:nvPr/>
          </p:nvSpPr>
          <p:spPr>
            <a:xfrm>
              <a:off x="4677840" y="518328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テキスト ボックス 35"/>
          <p:cNvSpPr/>
          <p:nvPr/>
        </p:nvSpPr>
        <p:spPr>
          <a:xfrm>
            <a:off x="363600" y="7348680"/>
            <a:ext cx="61722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data S2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sults of qRT-PCR analysis. Altered expressions of the PI3K-Akt signaling-related genes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DK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IK3C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IK3C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IK3C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IK3C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IK3D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were examined. The cyclophilin mRNA levels were used as a contro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テキスト ボックス 3"/>
          <p:cNvSpPr/>
          <p:nvPr/>
        </p:nvSpPr>
        <p:spPr>
          <a:xfrm>
            <a:off x="2137680" y="0"/>
            <a:ext cx="255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data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4"/>
          <p:cNvSpPr/>
          <p:nvPr/>
        </p:nvSpPr>
        <p:spPr>
          <a:xfrm>
            <a:off x="2476440" y="9536040"/>
            <a:ext cx="184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Watanabe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図形グループ 44"/>
          <p:cNvGrpSpPr/>
          <p:nvPr/>
        </p:nvGrpSpPr>
        <p:grpSpPr>
          <a:xfrm>
            <a:off x="1498320" y="2166840"/>
            <a:ext cx="4777200" cy="4051080"/>
            <a:chOff x="1498320" y="2166840"/>
            <a:chExt cx="4777200" cy="4051080"/>
          </a:xfrm>
        </p:grpSpPr>
        <p:sp>
          <p:nvSpPr>
            <p:cNvPr id="91" name="テキスト ボックス 7"/>
            <p:cNvSpPr/>
            <p:nvPr/>
          </p:nvSpPr>
          <p:spPr>
            <a:xfrm>
              <a:off x="1498320" y="216684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テキスト ボックス 21"/>
            <p:cNvSpPr/>
            <p:nvPr/>
          </p:nvSpPr>
          <p:spPr>
            <a:xfrm>
              <a:off x="4422960" y="3454200"/>
              <a:ext cx="1852560" cy="41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marL="343080" indent="-343080">
                <a:spcAft>
                  <a:spcPts val="601"/>
                </a:spcAft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   Control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spcAft>
                  <a:spcPts val="601"/>
                </a:spcAft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.</a:t>
              </a: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BRG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3" name="Group 44"/>
            <p:cNvGrpSpPr/>
            <p:nvPr/>
          </p:nvGrpSpPr>
          <p:grpSpPr>
            <a:xfrm>
              <a:off x="1572840" y="2847600"/>
              <a:ext cx="3201840" cy="1147680"/>
              <a:chOff x="1572840" y="2847600"/>
              <a:chExt cx="3201840" cy="1147680"/>
            </a:xfrm>
          </p:grpSpPr>
          <p:sp>
            <p:nvSpPr>
              <p:cNvPr id="94" name="テキスト ボックス 6"/>
              <p:cNvSpPr/>
              <p:nvPr/>
            </p:nvSpPr>
            <p:spPr>
              <a:xfrm>
                <a:off x="2279160" y="3174480"/>
                <a:ext cx="298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テキスト ボックス 8"/>
              <p:cNvSpPr/>
              <p:nvPr/>
            </p:nvSpPr>
            <p:spPr>
              <a:xfrm>
                <a:off x="1572840" y="3390480"/>
                <a:ext cx="796680" cy="565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spcAft>
                    <a:spcPts val="1800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catenin –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100000"/>
                  </a:lnSpc>
                  <a:spcAft>
                    <a:spcPts val="1800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actin –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テキスト ボックス 22"/>
              <p:cNvSpPr/>
              <p:nvPr/>
            </p:nvSpPr>
            <p:spPr>
              <a:xfrm>
                <a:off x="2490120" y="3174480"/>
                <a:ext cx="298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直線コネクタ 24"/>
              <p:cNvSpPr/>
              <p:nvPr/>
            </p:nvSpPr>
            <p:spPr>
              <a:xfrm>
                <a:off x="2293560" y="3174480"/>
                <a:ext cx="49032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テキスト ボックス 25"/>
              <p:cNvSpPr/>
              <p:nvPr/>
            </p:nvSpPr>
            <p:spPr>
              <a:xfrm>
                <a:off x="2220480" y="2969640"/>
                <a:ext cx="647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ytoso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テキスト ボックス 27"/>
              <p:cNvSpPr/>
              <p:nvPr/>
            </p:nvSpPr>
            <p:spPr>
              <a:xfrm>
                <a:off x="2831400" y="3174480"/>
                <a:ext cx="298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テキスト ボックス 29"/>
              <p:cNvSpPr/>
              <p:nvPr/>
            </p:nvSpPr>
            <p:spPr>
              <a:xfrm>
                <a:off x="3042720" y="3174480"/>
                <a:ext cx="298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直線コネクタ 30"/>
              <p:cNvSpPr/>
              <p:nvPr/>
            </p:nvSpPr>
            <p:spPr>
              <a:xfrm>
                <a:off x="2845800" y="3174480"/>
                <a:ext cx="49212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テキスト ボックス 31"/>
              <p:cNvSpPr/>
              <p:nvPr/>
            </p:nvSpPr>
            <p:spPr>
              <a:xfrm>
                <a:off x="2718720" y="2847600"/>
                <a:ext cx="766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embrane/organell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テキスト ボックス 33"/>
              <p:cNvSpPr/>
              <p:nvPr/>
            </p:nvSpPr>
            <p:spPr>
              <a:xfrm>
                <a:off x="3385440" y="3174480"/>
                <a:ext cx="298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テキスト ボックス 35"/>
              <p:cNvSpPr/>
              <p:nvPr/>
            </p:nvSpPr>
            <p:spPr>
              <a:xfrm>
                <a:off x="3596760" y="3174480"/>
                <a:ext cx="298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直線コネクタ 36"/>
              <p:cNvSpPr/>
              <p:nvPr/>
            </p:nvSpPr>
            <p:spPr>
              <a:xfrm>
                <a:off x="3399840" y="3174480"/>
                <a:ext cx="49212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テキスト ボックス 37"/>
              <p:cNvSpPr/>
              <p:nvPr/>
            </p:nvSpPr>
            <p:spPr>
              <a:xfrm>
                <a:off x="3325320" y="2969640"/>
                <a:ext cx="649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ucle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テキスト ボックス 39"/>
              <p:cNvSpPr/>
              <p:nvPr/>
            </p:nvSpPr>
            <p:spPr>
              <a:xfrm>
                <a:off x="3938040" y="3174480"/>
                <a:ext cx="298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テキスト ボックス 41"/>
              <p:cNvSpPr/>
              <p:nvPr/>
            </p:nvSpPr>
            <p:spPr>
              <a:xfrm>
                <a:off x="4149000" y="3174480"/>
                <a:ext cx="29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直線コネクタ 42"/>
              <p:cNvSpPr/>
              <p:nvPr/>
            </p:nvSpPr>
            <p:spPr>
              <a:xfrm>
                <a:off x="3952440" y="3174480"/>
                <a:ext cx="49212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10" name="Picture 36" descr=""/>
              <p:cNvPicPr/>
              <p:nvPr/>
            </p:nvPicPr>
            <p:blipFill>
              <a:blip r:embed="rId1"/>
              <a:stretch/>
            </p:blipFill>
            <p:spPr>
              <a:xfrm>
                <a:off x="2317320" y="3358440"/>
                <a:ext cx="488880" cy="277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1" name="Picture 37" descr=""/>
              <p:cNvPicPr/>
              <p:nvPr/>
            </p:nvPicPr>
            <p:blipFill>
              <a:blip r:embed="rId2"/>
              <a:stretch/>
            </p:blipFill>
            <p:spPr>
              <a:xfrm>
                <a:off x="2845800" y="3358440"/>
                <a:ext cx="495360" cy="277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2" name="Picture 38" descr=""/>
              <p:cNvPicPr/>
              <p:nvPr/>
            </p:nvPicPr>
            <p:blipFill>
              <a:blip r:embed="rId3"/>
              <a:stretch/>
            </p:blipFill>
            <p:spPr>
              <a:xfrm>
                <a:off x="3399840" y="3366720"/>
                <a:ext cx="488880" cy="261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3" name="Picture 39" descr=""/>
              <p:cNvPicPr/>
              <p:nvPr/>
            </p:nvPicPr>
            <p:blipFill>
              <a:blip r:embed="rId4"/>
              <a:stretch/>
            </p:blipFill>
            <p:spPr>
              <a:xfrm>
                <a:off x="3949200" y="3366720"/>
                <a:ext cx="488880" cy="261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4" name="Picture 40" descr=""/>
              <p:cNvPicPr/>
              <p:nvPr/>
            </p:nvPicPr>
            <p:blipFill>
              <a:blip r:embed="rId5"/>
              <a:stretch/>
            </p:blipFill>
            <p:spPr>
              <a:xfrm>
                <a:off x="2309400" y="3715920"/>
                <a:ext cx="488880" cy="261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5" name="Picture 41" descr=""/>
              <p:cNvPicPr/>
              <p:nvPr/>
            </p:nvPicPr>
            <p:blipFill>
              <a:blip r:embed="rId6"/>
              <a:stretch/>
            </p:blipFill>
            <p:spPr>
              <a:xfrm>
                <a:off x="2845800" y="3733200"/>
                <a:ext cx="503280" cy="262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6" name="Picture 42" descr=""/>
              <p:cNvPicPr/>
              <p:nvPr/>
            </p:nvPicPr>
            <p:blipFill>
              <a:blip r:embed="rId7"/>
              <a:stretch/>
            </p:blipFill>
            <p:spPr>
              <a:xfrm>
                <a:off x="3399840" y="3733200"/>
                <a:ext cx="488880" cy="262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7" name="Picture 43" descr=""/>
              <p:cNvPicPr/>
              <p:nvPr/>
            </p:nvPicPr>
            <p:blipFill>
              <a:blip r:embed="rId8"/>
              <a:stretch/>
            </p:blipFill>
            <p:spPr>
              <a:xfrm>
                <a:off x="3938040" y="3715920"/>
                <a:ext cx="488880" cy="261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8" name="テキスト ボックス 31"/>
              <p:cNvSpPr/>
              <p:nvPr/>
            </p:nvSpPr>
            <p:spPr>
              <a:xfrm>
                <a:off x="3661920" y="2891880"/>
                <a:ext cx="111276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50000"/>
                  </a:lnSpc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ytoskeleto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50000"/>
                  </a:lnSpc>
                  <a:spcAft>
                    <a:spcPts val="601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/matrix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9" name="Group 62"/>
            <p:cNvGrpSpPr/>
            <p:nvPr/>
          </p:nvGrpSpPr>
          <p:grpSpPr>
            <a:xfrm>
              <a:off x="1506240" y="4211640"/>
              <a:ext cx="2954520" cy="2006280"/>
              <a:chOff x="1506240" y="4211640"/>
              <a:chExt cx="2954520" cy="2006280"/>
            </a:xfrm>
          </p:grpSpPr>
          <p:sp>
            <p:nvSpPr>
              <p:cNvPr id="120" name="テキスト ボックス 11"/>
              <p:cNvSpPr/>
              <p:nvPr/>
            </p:nvSpPr>
            <p:spPr>
              <a:xfrm>
                <a:off x="1506240" y="4211640"/>
                <a:ext cx="3268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21" name="Picture 54" descr=""/>
              <p:cNvPicPr/>
              <p:nvPr/>
            </p:nvPicPr>
            <p:blipFill>
              <a:blip r:embed="rId9"/>
              <a:stretch/>
            </p:blipFill>
            <p:spPr>
              <a:xfrm>
                <a:off x="2469960" y="4410000"/>
                <a:ext cx="1990800" cy="164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2" name="テキスト ボックス 13"/>
              <p:cNvSpPr/>
              <p:nvPr/>
            </p:nvSpPr>
            <p:spPr>
              <a:xfrm rot="16200000">
                <a:off x="1500480" y="5069520"/>
                <a:ext cx="1355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yclin D1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mRNA leve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/Cyclophilin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テキスト ボックス 14"/>
              <p:cNvSpPr/>
              <p:nvPr/>
            </p:nvSpPr>
            <p:spPr>
              <a:xfrm>
                <a:off x="2528640" y="6002280"/>
                <a:ext cx="947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ntrol siRN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テキスト ボックス 15"/>
              <p:cNvSpPr/>
              <p:nvPr/>
            </p:nvSpPr>
            <p:spPr>
              <a:xfrm>
                <a:off x="3476520" y="6002280"/>
                <a:ext cx="947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RG1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siRN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Text Box 55"/>
              <p:cNvSpPr/>
              <p:nvPr/>
            </p:nvSpPr>
            <p:spPr>
              <a:xfrm>
                <a:off x="2323800" y="5892480"/>
                <a:ext cx="2448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Text Box 56"/>
              <p:cNvSpPr/>
              <p:nvPr/>
            </p:nvSpPr>
            <p:spPr>
              <a:xfrm>
                <a:off x="2228040" y="5479920"/>
                <a:ext cx="340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Text Box 57"/>
              <p:cNvSpPr/>
              <p:nvPr/>
            </p:nvSpPr>
            <p:spPr>
              <a:xfrm>
                <a:off x="2323800" y="5111640"/>
                <a:ext cx="2448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Text Box 58"/>
              <p:cNvSpPr/>
              <p:nvPr/>
            </p:nvSpPr>
            <p:spPr>
              <a:xfrm>
                <a:off x="2228040" y="4736880"/>
                <a:ext cx="340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Text Box 59"/>
              <p:cNvSpPr/>
              <p:nvPr/>
            </p:nvSpPr>
            <p:spPr>
              <a:xfrm>
                <a:off x="2323800" y="4338360"/>
                <a:ext cx="2448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30" name="テキスト ボックス 43"/>
          <p:cNvSpPr/>
          <p:nvPr/>
        </p:nvSpPr>
        <p:spPr>
          <a:xfrm>
            <a:off x="363600" y="7348680"/>
            <a:ext cx="61722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data S3. (A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amount of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catenin in subcellular fractions in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G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iRNA- and control siRNA-transfected DLD-1 cells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clin D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RNA levels in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G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iRNA- and control siRNA-transfected DLD-1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1T02:13:14Z</dcterms:created>
  <dc:creator>仙波 秀峰</dc:creator>
  <dc:description/>
  <dc:language>en-US</dc:language>
  <cp:lastModifiedBy>仙波 秀峰</cp:lastModifiedBy>
  <cp:lastPrinted>2010-10-20T02:48:56Z</cp:lastPrinted>
  <dcterms:modified xsi:type="dcterms:W3CDTF">2010-10-21T02:29:18Z</dcterms:modified>
  <cp:revision>204</cp:revision>
  <dc:subject/>
  <dc:title>スライド 1</dc:title>
</cp:coreProperties>
</file>